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6220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144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2584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7818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4777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1380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3951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533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5693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4247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461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1674D-F6D7-4D96-B8D0-CF1BAE55E963}" type="datetimeFigureOut">
              <a:rPr lang="zh-CN" altLang="en-US" smtClean="0"/>
              <a:t>2020-11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6054A-8771-48D7-805A-A52BAAA4E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351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76518" y="632012"/>
            <a:ext cx="3262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j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78" t="26256" r="13699" b="21385"/>
          <a:stretch/>
        </p:blipFill>
        <p:spPr>
          <a:xfrm>
            <a:off x="2649071" y="2420470"/>
            <a:ext cx="3240741" cy="24742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43" t="44053" r="15145" b="50776"/>
          <a:stretch/>
        </p:blipFill>
        <p:spPr>
          <a:xfrm>
            <a:off x="2649071" y="4988858"/>
            <a:ext cx="3240741" cy="4303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2017059" y="2043956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robe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922491" y="2048439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-3360000">
            <a:off x="3155573" y="1971743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-3360000">
            <a:off x="3563466" y="2016567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 rot="-3360000">
            <a:off x="3944465" y="2007603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419591" y="202602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 rot="-3360000">
            <a:off x="4652673" y="201208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 rot="-3360000">
            <a:off x="5060566" y="201208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 rot="-3360000">
            <a:off x="5414671" y="201208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291074" y="1509539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613363" y="1540916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8" name="直接连接符 17"/>
          <p:cNvCxnSpPr>
            <a:endCxn id="11" idx="3"/>
          </p:cNvCxnSpPr>
          <p:nvPr/>
        </p:nvCxnSpPr>
        <p:spPr>
          <a:xfrm>
            <a:off x="2949385" y="1896039"/>
            <a:ext cx="1440222" cy="4415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4481494" y="1935108"/>
            <a:ext cx="1431885" cy="12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2945652" y="1223854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889812" y="4986474"/>
            <a:ext cx="248497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</a:t>
            </a:r>
          </a:p>
          <a:p>
            <a:r>
              <a:rPr lang="zh-CN" altLang="en-US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（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GRB2</a:t>
            </a:r>
            <a:r>
              <a:rPr lang="zh-CN" altLang="en-US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）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889812" y="3525239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057400" y="507672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2456245" y="5246004"/>
            <a:ext cx="180000" cy="59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516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9485" y="3031752"/>
            <a:ext cx="2705100" cy="1924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/>
          <a:srcRect t="25000"/>
          <a:stretch/>
        </p:blipFill>
        <p:spPr>
          <a:xfrm>
            <a:off x="2823882" y="5026823"/>
            <a:ext cx="2710703" cy="4326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文本框 1"/>
          <p:cNvSpPr txBox="1"/>
          <p:nvPr/>
        </p:nvSpPr>
        <p:spPr>
          <a:xfrm>
            <a:off x="2178423" y="2581836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robe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083855" y="2586319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 rot="-3360000">
            <a:off x="3316937" y="2549964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-3360000">
            <a:off x="3617254" y="2594788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-3360000">
            <a:off x="3931018" y="2585824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325462" y="2604249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 rot="-3360000">
            <a:off x="4558544" y="259030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 rot="-3360000">
            <a:off x="4858861" y="259030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 rot="-3360000">
            <a:off x="5172625" y="259030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3452438" y="2087760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519234" y="2119137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3191431" y="2474260"/>
            <a:ext cx="1152000" cy="224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4446485" y="2519084"/>
            <a:ext cx="1152000" cy="224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5562627" y="3932802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093569" y="1828969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376518" y="632012"/>
            <a:ext cx="3262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j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598485" y="4955802"/>
            <a:ext cx="248497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</a:t>
            </a:r>
          </a:p>
          <a:p>
            <a:r>
              <a:rPr lang="zh-CN" altLang="en-US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（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GRB2</a:t>
            </a:r>
            <a:r>
              <a:rPr lang="zh-CN" altLang="en-US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）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245658" y="507672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644503" y="5246004"/>
            <a:ext cx="180000" cy="59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8342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76518" y="632012"/>
            <a:ext cx="3262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j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48607" y="2891118"/>
            <a:ext cx="2826052" cy="24204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83" t="22195" r="40789" b="68367"/>
          <a:stretch/>
        </p:blipFill>
        <p:spPr>
          <a:xfrm>
            <a:off x="2848607" y="5439800"/>
            <a:ext cx="2826052" cy="4634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2003612" y="2487707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robe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909044" y="249219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 rot="-3360000">
            <a:off x="3142126" y="245583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-3360000">
            <a:off x="3496231" y="2500659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 rot="-3360000">
            <a:off x="3809995" y="2491695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298568" y="2510120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 rot="-3360000">
            <a:off x="4531650" y="2496177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 rot="-3360000">
            <a:off x="4885755" y="2496177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6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 rot="-3360000">
            <a:off x="5226413" y="2496177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8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277627" y="1993631"/>
            <a:ext cx="64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nput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492340" y="2025008"/>
            <a:ext cx="10823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ull-dow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3016620" y="2380131"/>
            <a:ext cx="1152000" cy="224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4459932" y="2398061"/>
            <a:ext cx="1152000" cy="224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932205" y="1546582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683650" y="3932802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719508" y="5386106"/>
            <a:ext cx="248497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</a:t>
            </a:r>
          </a:p>
          <a:p>
            <a:r>
              <a:rPr lang="zh-CN" altLang="en-US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（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GRB2</a:t>
            </a:r>
            <a:r>
              <a:rPr lang="zh-CN" altLang="en-US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）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259105" y="558771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657950" y="5756990"/>
            <a:ext cx="180000" cy="59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24097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61366" y="161365"/>
            <a:ext cx="4128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</a:t>
            </a:r>
            <a:r>
              <a:rPr lang="en-US" altLang="zh-CN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j</a:t>
            </a:r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. 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4684" y="714217"/>
            <a:ext cx="4294632" cy="5940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8626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</TotalTime>
  <Words>82</Words>
  <Application>Microsoft Office PowerPoint</Application>
  <PresentationFormat>全屏显示(4:3)</PresentationFormat>
  <Paragraphs>5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2</cp:revision>
  <dcterms:created xsi:type="dcterms:W3CDTF">2020-08-31T02:09:21Z</dcterms:created>
  <dcterms:modified xsi:type="dcterms:W3CDTF">2020-11-12T10:30:31Z</dcterms:modified>
</cp:coreProperties>
</file>